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957B16-7F41-4637-BF5B-DAB220AAD6A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CC32BA-5CAC-43C9-A8EE-FC7A3CF91F7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44CD9-413B-4ADF-B522-67F2845B01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F1556-139F-4E47-B5A6-63B382D837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31F33-BE83-4598-A73B-5D8BC3C651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695A7-17DE-4432-B2FB-F9AE0283A0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71F179-9E95-40D7-B7BE-9FF1426626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5EF85-6701-417F-978B-0FA9D20F5C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CCA14-5534-44DE-A49F-AF1373FFF7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45A66-ABF9-47EA-B3A0-C171ABFF5E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B1BAAC-BFDA-40EF-8A16-2A446187AA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E13769-287D-4B46-83A3-3E053029D3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00AE96-5E21-4F7C-8E7B-9E76755923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7CFF7-109A-4A75-948F-8D6F2380A9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ABD803-8B43-4E25-A904-965722FB6CF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oleObject" Target="../embeddings/oleObject2.bin"/><Relationship Id="rId5" Type="http://schemas.openxmlformats.org/officeDocument/2006/relationships/image" Target="../media/image3.png"/><Relationship Id="rId6" Type="http://schemas.openxmlformats.org/officeDocument/2006/relationships/oleObject" Target="../embeddings/oleObject3.bin"/><Relationship Id="rId7" Type="http://schemas.openxmlformats.org/officeDocument/2006/relationships/image" Target="../media/image4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1"/>
          <p:cNvGrpSpPr/>
          <p:nvPr/>
        </p:nvGrpSpPr>
        <p:grpSpPr>
          <a:xfrm>
            <a:off x="276120" y="228600"/>
            <a:ext cx="8181360" cy="6599160"/>
            <a:chOff x="276120" y="228600"/>
            <a:chExt cx="8181360" cy="6599160"/>
          </a:xfrm>
        </p:grpSpPr>
        <p:sp>
          <p:nvSpPr>
            <p:cNvPr id="49" name="TextBox 42"/>
            <p:cNvSpPr/>
            <p:nvPr/>
          </p:nvSpPr>
          <p:spPr>
            <a:xfrm>
              <a:off x="276120" y="6457680"/>
              <a:ext cx="184320" cy="370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6"/>
            <p:cNvSpPr/>
            <p:nvPr/>
          </p:nvSpPr>
          <p:spPr>
            <a:xfrm>
              <a:off x="870480" y="280800"/>
              <a:ext cx="3225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Group 21"/>
            <p:cNvGrpSpPr/>
            <p:nvPr/>
          </p:nvGrpSpPr>
          <p:grpSpPr>
            <a:xfrm>
              <a:off x="456120" y="930240"/>
              <a:ext cx="4196520" cy="744480"/>
              <a:chOff x="456120" y="930240"/>
              <a:chExt cx="4196520" cy="744480"/>
            </a:xfrm>
          </p:grpSpPr>
          <p:graphicFrame>
            <p:nvGraphicFramePr>
              <p:cNvPr id="52" name="Object 14"/>
              <p:cNvGraphicFramePr/>
              <p:nvPr/>
            </p:nvGraphicFramePr>
            <p:xfrm>
              <a:off x="1341000" y="930240"/>
              <a:ext cx="3311640" cy="74448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53" name="Object 14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1341000" y="930240"/>
                        <a:ext cx="3311640" cy="744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54" name="Line 17"/>
              <p:cNvSpPr/>
              <p:nvPr/>
            </p:nvSpPr>
            <p:spPr>
              <a:xfrm>
                <a:off x="1498320" y="1362600"/>
                <a:ext cx="1429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 Box 18"/>
              <p:cNvSpPr/>
              <p:nvPr/>
            </p:nvSpPr>
            <p:spPr>
              <a:xfrm>
                <a:off x="456120" y="1273320"/>
                <a:ext cx="1063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FL APP-RF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" name="Group 8"/>
            <p:cNvGrpSpPr/>
            <p:nvPr/>
          </p:nvGrpSpPr>
          <p:grpSpPr>
            <a:xfrm>
              <a:off x="4795560" y="2766960"/>
              <a:ext cx="3661920" cy="2686320"/>
              <a:chOff x="4795560" y="2766960"/>
              <a:chExt cx="3661920" cy="2686320"/>
            </a:xfrm>
          </p:grpSpPr>
          <p:grpSp>
            <p:nvGrpSpPr>
              <p:cNvPr id="57" name="Group 15"/>
              <p:cNvGrpSpPr/>
              <p:nvPr/>
            </p:nvGrpSpPr>
            <p:grpSpPr>
              <a:xfrm>
                <a:off x="4795560" y="3091680"/>
                <a:ext cx="3661920" cy="2361600"/>
                <a:chOff x="4795560" y="3091680"/>
                <a:chExt cx="3661920" cy="2361600"/>
              </a:xfrm>
            </p:grpSpPr>
            <p:pic>
              <p:nvPicPr>
                <p:cNvPr id="58" name="グラフ 2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4943160" y="3486600"/>
                  <a:ext cx="3514320" cy="18223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9" name="テキスト ボックス 102"/>
                <p:cNvSpPr/>
                <p:nvPr/>
              </p:nvSpPr>
              <p:spPr>
                <a:xfrm>
                  <a:off x="5481720" y="3091680"/>
                  <a:ext cx="27914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APP/APLP2 dko Cell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直線コネクタ 18"/>
                <p:cNvSpPr/>
                <p:nvPr/>
              </p:nvSpPr>
              <p:spPr>
                <a:xfrm>
                  <a:off x="6854760" y="3491280"/>
                  <a:ext cx="99144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直線コネクタ 20"/>
                <p:cNvSpPr/>
                <p:nvPr/>
              </p:nvSpPr>
              <p:spPr>
                <a:xfrm>
                  <a:off x="7846200" y="3491280"/>
                  <a:ext cx="0" cy="228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直線コネクタ 20"/>
                <p:cNvSpPr/>
                <p:nvPr/>
              </p:nvSpPr>
              <p:spPr>
                <a:xfrm>
                  <a:off x="6854760" y="3491280"/>
                  <a:ext cx="0" cy="342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テキスト ボックス 95"/>
                <p:cNvSpPr/>
                <p:nvPr/>
              </p:nvSpPr>
              <p:spPr>
                <a:xfrm>
                  <a:off x="7209000" y="3381840"/>
                  <a:ext cx="229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*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TextBox 52"/>
                <p:cNvSpPr/>
                <p:nvPr/>
              </p:nvSpPr>
              <p:spPr>
                <a:xfrm rot="16200000">
                  <a:off x="4460040" y="3948120"/>
                  <a:ext cx="9169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GFP Lifetim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Straight Connector 29"/>
                <p:cNvSpPr/>
                <p:nvPr/>
              </p:nvSpPr>
              <p:spPr>
                <a:xfrm>
                  <a:off x="6549480" y="5207040"/>
                  <a:ext cx="17208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TextBox 30"/>
                <p:cNvSpPr/>
                <p:nvPr/>
              </p:nvSpPr>
              <p:spPr>
                <a:xfrm>
                  <a:off x="6749280" y="5207040"/>
                  <a:ext cx="1288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Wild-type APP-RFP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7" name="Text Box 19"/>
              <p:cNvSpPr/>
              <p:nvPr/>
            </p:nvSpPr>
            <p:spPr>
              <a:xfrm>
                <a:off x="4942080" y="2766960"/>
                <a:ext cx="32256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4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" name="Group 20"/>
            <p:cNvGrpSpPr/>
            <p:nvPr/>
          </p:nvGrpSpPr>
          <p:grpSpPr>
            <a:xfrm>
              <a:off x="5066280" y="228600"/>
              <a:ext cx="3165840" cy="2321640"/>
              <a:chOff x="5066280" y="228600"/>
              <a:chExt cx="3165840" cy="2321640"/>
            </a:xfrm>
          </p:grpSpPr>
          <p:grpSp>
            <p:nvGrpSpPr>
              <p:cNvPr id="69" name="Group 21"/>
              <p:cNvGrpSpPr/>
              <p:nvPr/>
            </p:nvGrpSpPr>
            <p:grpSpPr>
              <a:xfrm>
                <a:off x="5180040" y="281880"/>
                <a:ext cx="3052080" cy="2268360"/>
                <a:chOff x="5180040" y="281880"/>
                <a:chExt cx="3052080" cy="2268360"/>
              </a:xfrm>
            </p:grpSpPr>
            <p:grpSp>
              <p:nvGrpSpPr>
                <p:cNvPr id="70" name="Group 22"/>
                <p:cNvGrpSpPr/>
                <p:nvPr/>
              </p:nvGrpSpPr>
              <p:grpSpPr>
                <a:xfrm>
                  <a:off x="5208480" y="281880"/>
                  <a:ext cx="3023640" cy="2268360"/>
                  <a:chOff x="5208480" y="281880"/>
                  <a:chExt cx="3023640" cy="2268360"/>
                </a:xfrm>
              </p:grpSpPr>
              <p:grpSp>
                <p:nvGrpSpPr>
                  <p:cNvPr id="71" name="Group 23"/>
                  <p:cNvGrpSpPr/>
                  <p:nvPr/>
                </p:nvGrpSpPr>
                <p:grpSpPr>
                  <a:xfrm>
                    <a:off x="5208480" y="281880"/>
                    <a:ext cx="3023640" cy="2268360"/>
                    <a:chOff x="5208480" y="281880"/>
                    <a:chExt cx="3023640" cy="2268360"/>
                  </a:xfrm>
                </p:grpSpPr>
                <p:grpSp>
                  <p:nvGrpSpPr>
                    <p:cNvPr id="72" name="Group 24"/>
                    <p:cNvGrpSpPr/>
                    <p:nvPr/>
                  </p:nvGrpSpPr>
                  <p:grpSpPr>
                    <a:xfrm>
                      <a:off x="5208480" y="322560"/>
                      <a:ext cx="3023640" cy="2227680"/>
                      <a:chOff x="5208480" y="322560"/>
                      <a:chExt cx="3023640" cy="2227680"/>
                    </a:xfrm>
                  </p:grpSpPr>
                  <p:graphicFrame>
                    <p:nvGraphicFramePr>
                      <p:cNvPr id="73" name="Object 19"/>
                      <p:cNvGraphicFramePr/>
                      <p:nvPr/>
                    </p:nvGraphicFramePr>
                    <p:xfrm>
                      <a:off x="5208480" y="322560"/>
                      <a:ext cx="3023640" cy="2227680"/>
                    </p:xfrm>
                    <a:graphic>
                      <a:graphicData uri="http://schemas.openxmlformats.org/presentationml/2006/ole">
                        <p:oleObj r:id="rId4" spid="">
                          <p:embed/>
                          <p:pic>
                            <p:nvPicPr>
                              <p:cNvPr id="74" name="Object 19" descr=""/>
                              <p:cNvPicPr/>
                              <p:nvPr/>
                            </p:nvPicPr>
                            <p:blipFill>
                              <a:blip r:embed="rId5"/>
                              <a:stretch/>
                            </p:blipFill>
                            <p:spPr>
                              <a:xfrm>
                                <a:off x="5208480" y="322560"/>
                                <a:ext cx="3023640" cy="2227680"/>
                              </a:xfrm>
                              <a:prstGeom prst="rect">
                                <a:avLst/>
                              </a:prstGeom>
                              <a:ln w="0">
                                <a:noFill/>
                              </a:ln>
                            </p:spPr>
                          </p:pic>
                        </p:oleObj>
                      </a:graphicData>
                    </a:graphic>
                  </p:graphicFrame>
                  <p:sp>
                    <p:nvSpPr>
                      <p:cNvPr id="75" name="Rectangle 26"/>
                      <p:cNvSpPr/>
                      <p:nvPr/>
                    </p:nvSpPr>
                    <p:spPr>
                      <a:xfrm>
                        <a:off x="5372280" y="1735920"/>
                        <a:ext cx="247680" cy="17424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360">
                        <a:solidFill>
                          <a:srgbClr val="fffff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76" name="Rectangle 27"/>
                    <p:cNvSpPr/>
                    <p:nvPr/>
                  </p:nvSpPr>
                  <p:spPr>
                    <a:xfrm>
                      <a:off x="5208480" y="281880"/>
                      <a:ext cx="329400" cy="104652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9360">
                      <a:solidFill>
                        <a:srgbClr val="ffff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77" name="Rectangle 28"/>
                  <p:cNvSpPr/>
                  <p:nvPr/>
                </p:nvSpPr>
                <p:spPr>
                  <a:xfrm>
                    <a:off x="6360840" y="335520"/>
                    <a:ext cx="1079640" cy="16164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8" name="Rectangle 29"/>
                <p:cNvSpPr/>
                <p:nvPr/>
              </p:nvSpPr>
              <p:spPr>
                <a:xfrm rot="16200000">
                  <a:off x="4844520" y="766080"/>
                  <a:ext cx="9169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GFP Lifetim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9" name="Rectangle 30"/>
              <p:cNvSpPr/>
              <p:nvPr/>
            </p:nvSpPr>
            <p:spPr>
              <a:xfrm>
                <a:off x="6287760" y="228600"/>
                <a:ext cx="175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APP/APLP2 dko Cell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 Box 31"/>
              <p:cNvSpPr/>
              <p:nvPr/>
            </p:nvSpPr>
            <p:spPr>
              <a:xfrm>
                <a:off x="5066280" y="265320"/>
                <a:ext cx="32256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1" name="Group 32"/>
            <p:cNvGrpSpPr/>
            <p:nvPr/>
          </p:nvGrpSpPr>
          <p:grpSpPr>
            <a:xfrm>
              <a:off x="889560" y="2712960"/>
              <a:ext cx="3597840" cy="2538000"/>
              <a:chOff x="889560" y="2712960"/>
              <a:chExt cx="3597840" cy="2538000"/>
            </a:xfrm>
          </p:grpSpPr>
          <p:sp>
            <p:nvSpPr>
              <p:cNvPr id="82" name="Text Box 33"/>
              <p:cNvSpPr/>
              <p:nvPr/>
            </p:nvSpPr>
            <p:spPr>
              <a:xfrm>
                <a:off x="889560" y="2712960"/>
                <a:ext cx="32256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3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3" name="Group 34"/>
              <p:cNvGrpSpPr/>
              <p:nvPr/>
            </p:nvGrpSpPr>
            <p:grpSpPr>
              <a:xfrm>
                <a:off x="1176120" y="2876040"/>
                <a:ext cx="3311280" cy="2374920"/>
                <a:chOff x="1176120" y="2876040"/>
                <a:chExt cx="3311280" cy="2374920"/>
              </a:xfrm>
            </p:grpSpPr>
            <p:grpSp>
              <p:nvGrpSpPr>
                <p:cNvPr id="84" name="Group 35"/>
                <p:cNvGrpSpPr/>
                <p:nvPr/>
              </p:nvGrpSpPr>
              <p:grpSpPr>
                <a:xfrm>
                  <a:off x="1176120" y="2928240"/>
                  <a:ext cx="3311280" cy="2322720"/>
                  <a:chOff x="1176120" y="2928240"/>
                  <a:chExt cx="3311280" cy="2322720"/>
                </a:xfrm>
              </p:grpSpPr>
              <p:graphicFrame>
                <p:nvGraphicFramePr>
                  <p:cNvPr id="85" name="Object 20"/>
                  <p:cNvGraphicFramePr/>
                  <p:nvPr/>
                </p:nvGraphicFramePr>
                <p:xfrm>
                  <a:off x="1176120" y="2928240"/>
                  <a:ext cx="3311280" cy="2322720"/>
                </p:xfrm>
                <a:graphic>
                  <a:graphicData uri="http://schemas.openxmlformats.org/presentationml/2006/ole">
                    <p:oleObj r:id="rId6" spid="">
                      <p:embed/>
                      <p:pic>
                        <p:nvPicPr>
                          <p:cNvPr id="86" name="Object 20" descr=""/>
                          <p:cNvPicPr/>
                          <p:nvPr/>
                        </p:nvPicPr>
                        <p:blipFill>
                          <a:blip r:embed="rId7"/>
                          <a:stretch/>
                        </p:blipFill>
                        <p:spPr>
                          <a:xfrm>
                            <a:off x="1176120" y="2928240"/>
                            <a:ext cx="3311280" cy="2322720"/>
                          </a:xfrm>
                          <a:prstGeom prst="rect">
                            <a:avLst/>
                          </a:prstGeom>
                          <a:ln w="0">
                            <a:noFill/>
                          </a:ln>
                        </p:spPr>
                      </p:pic>
                    </p:oleObj>
                  </a:graphicData>
                </a:graphic>
              </p:graphicFrame>
              <p:sp>
                <p:nvSpPr>
                  <p:cNvPr id="87" name="Rectangle 37"/>
                  <p:cNvSpPr/>
                  <p:nvPr/>
                </p:nvSpPr>
                <p:spPr>
                  <a:xfrm>
                    <a:off x="1250280" y="2928240"/>
                    <a:ext cx="302040" cy="173232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8" name="Rectangle 38"/>
                <p:cNvSpPr/>
                <p:nvPr/>
              </p:nvSpPr>
              <p:spPr>
                <a:xfrm rot="16200000">
                  <a:off x="953280" y="3305160"/>
                  <a:ext cx="9169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GFP Lifetim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Rectangle 39"/>
                <p:cNvSpPr/>
                <p:nvPr/>
              </p:nvSpPr>
              <p:spPr>
                <a:xfrm>
                  <a:off x="2544480" y="2876040"/>
                  <a:ext cx="1295640" cy="2689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0" name="Text Box 40"/>
              <p:cNvSpPr/>
              <p:nvPr/>
            </p:nvSpPr>
            <p:spPr>
              <a:xfrm>
                <a:off x="2399400" y="2885400"/>
                <a:ext cx="1320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S1/2 dko Cell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06T19:48:52Z</dcterms:created>
  <dc:creator>Oksana Berezovska</dc:creator>
  <dc:description/>
  <dc:language>en-US</dc:language>
  <cp:lastModifiedBy> </cp:lastModifiedBy>
  <dcterms:modified xsi:type="dcterms:W3CDTF">2011-02-03T14:52:55Z</dcterms:modified>
  <cp:revision>4</cp:revision>
  <dc:subject/>
  <dc:title>Slide 1</dc:title>
</cp:coreProperties>
</file>